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8" r:id="rId2"/>
    <p:sldId id="279" r:id="rId3"/>
    <p:sldId id="280" r:id="rId4"/>
    <p:sldId id="281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00"/>
    <a:srgbClr val="FF0066"/>
    <a:srgbClr val="FFFF99"/>
    <a:srgbClr val="4A05B3"/>
    <a:srgbClr val="1CB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6374" autoAdjust="0"/>
  </p:normalViewPr>
  <p:slideViewPr>
    <p:cSldViewPr snapToGrid="0">
      <p:cViewPr varScale="1">
        <p:scale>
          <a:sx n="97" d="100"/>
          <a:sy n="97" d="100"/>
        </p:scale>
        <p:origin x="3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FF4B38-0B80-4898-96D4-3A8D6FFF5F90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954AF3-C61B-4B93-A2A3-AB7D95F0B0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10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A8BE42-28AD-6318-0C08-0E8F863255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92B7006-CF5B-E40A-F60E-EFE1A6904F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A5D53E6-DC2C-38E6-EF3F-25085AB0A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36484E-3CCB-1B9C-B660-029DEAF44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4A4BFAB-F25A-2CE2-F923-14F9823D6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5021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3A3710-BF0E-D30E-82C4-AA60EA20DA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568A5CC-BBF7-75D9-F2D4-5FD8235AE8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F1A73DD-DE2B-1FAE-BDA5-9076A67B6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4EFED6-3240-FF78-AD1F-0935E9D03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301298-220B-FE53-A87F-D2364C17B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8877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FE53676-E1AE-EE7D-57B6-FFD3403BB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1425E53-DD00-7662-E74D-20E1991B25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E064A4-6DA9-DB49-E1DF-925095C30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DF6EF4C-349A-01CB-7C1A-772F70E73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230155-63F0-6E3A-705F-7276C3804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2287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D8B2FE-7C5F-5A87-C9A9-14FFB09458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EABD13F-FB80-C910-0A27-F2C23B00D9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FBE6D7-9004-65A9-A7B5-CEE25E6C5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E2D07FB-47EF-C171-AC33-9C0FC829F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9DBEEE1-DAB3-7092-8352-2BBE52CD8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411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799AD6-F80F-1411-AAFA-B340A4516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6C82598-826D-8611-093B-50010E0FF0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10D3C2-D696-EB9A-7F0A-78203BFB5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3245FAE-9161-7BAB-584B-F137CBD55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4D76F67-5024-BA26-BAE6-527B7244A4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8563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BD9643-5E1D-5D14-1B51-AF3CBA8B1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47F57C2-743E-790E-3471-7E838F789B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52718FF-B0F8-C391-74C5-80165FA46D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5FB70BC-22EE-91CD-5957-0FD362A93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FC54779-289C-92F0-7760-5DE66EC25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1939C34-DDF1-3E02-87AD-4C16F8E67A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460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49A942E-7A5B-3817-E574-7B5B2D219E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1C08594-857C-737C-C7E2-022D20B597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1661336-A773-9985-35C7-1BACE83557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5B6B125-4991-64E9-1950-0384F59476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DB729EB-601F-133A-779B-4C38CBD7E3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6C7E402-0DBA-BEDF-D8CB-2CEF87332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45CE091-0C35-5944-C9B9-DE1181D3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C0C3EBC-60FA-6AD1-2AFE-74A1D87029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0868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4C5B6B-0868-C162-0ABD-5742D08B2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3D8FD57-EAF2-6ADE-F3B2-5F9D7365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B22FF75-24ED-A15F-48FE-81E6E376E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F8C2D3C-F8C7-88C0-D782-528825B3C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3929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7D45746-1895-9769-C9B0-AA0419AC3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C3029F1-CF19-307F-2DE8-BB29AF723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2738863-EAF0-443E-17E8-C709770B6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1194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078D78-4510-498E-A132-F62EAD91CE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B306FB1-9687-B948-5CAA-005553A9B7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F83C6D9-492A-CAEF-ADDE-8049591F97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0435ED-49C5-BA87-5458-981E2094D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924297A-8E40-3357-56E7-1AE444152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FD1FEE9-D783-F9D0-824A-97C931E62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0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ED2DFE-D394-AD22-B29C-F49927721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966BAC0-7E9E-BFC4-3DFF-0B8C3167BD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4321431-7593-F2E7-842D-E6F1621171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DB39DE5-3B3D-EAAC-D127-1E4555870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ED44A4F-A95A-20E7-E795-83C407473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641FA8D-A04F-7C62-90F3-13634B748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52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9FDD289-2E77-226B-B92B-408A94E5F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C0C0FDD-AB92-3D26-C918-9F62AD75E6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852EBF0-05F0-7192-6919-140A89B2F1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08893B-208A-46A7-977B-925F6C57006B}" type="datetimeFigureOut">
              <a:rPr lang="en-GB" smtClean="0"/>
              <a:t>16/11/2022</a:t>
            </a:fld>
            <a:endParaRPr lang="en-GB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9A0E3B-37C2-54A9-3127-557DB3A110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FEF12E9-3E66-775B-92F1-E76A895E43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2BAE9-58CB-449B-BF5D-0FB3F0E85C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22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svg"/><Relationship Id="rId7" Type="http://schemas.openxmlformats.org/officeDocument/2006/relationships/image" Target="../media/image8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svg"/><Relationship Id="rId4" Type="http://schemas.openxmlformats.org/officeDocument/2006/relationships/image" Target="../media/image5.png"/><Relationship Id="rId9" Type="http://schemas.openxmlformats.org/officeDocument/2006/relationships/image" Target="../media/image10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sv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sv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que 14">
            <a:extLst>
              <a:ext uri="{FF2B5EF4-FFF2-40B4-BE49-F238E27FC236}">
                <a16:creationId xmlns:a16="http://schemas.microsoft.com/office/drawing/2014/main" id="{1CE8C433-ACC9-07EB-5348-3EF6DE10C9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294662" y="412292"/>
            <a:ext cx="5760720" cy="4227195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E0D1FD8-8DC1-BC9C-B061-348BFA840E15}"/>
              </a:ext>
            </a:extLst>
          </p:cNvPr>
          <p:cNvSpPr txBox="1"/>
          <p:nvPr/>
        </p:nvSpPr>
        <p:spPr>
          <a:xfrm>
            <a:off x="1337186" y="4826675"/>
            <a:ext cx="949796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1. Relation between MFI-20 and FACIT-F total score. </a:t>
            </a: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two horizontal black lines represent FACIT-F scores in cancer patients from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a</a:t>
            </a: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t al. (2002), the solid one represents the cut-off used in this study, separating individuals with a high degree of fatigue from those with a low degree of fatigue. Linear regression lines with shaded confidence intervals filled with the respective colours between groups are represented. Pearson’s correlation coefficients with the p-values are displayed. A high degree of agreement can be noted between the two questionnaires. 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-20: Multidimensional fatigue inventory; FACIT-F: Functional assessment in chronic illness therapy fatigue scale; CKD: chronic kidney disease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0669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43">
            <a:extLst>
              <a:ext uri="{FF2B5EF4-FFF2-40B4-BE49-F238E27FC236}">
                <a16:creationId xmlns:a16="http://schemas.microsoft.com/office/drawing/2014/main" id="{8909E6E1-4473-E16D-9764-385498F11F78}"/>
              </a:ext>
            </a:extLst>
          </p:cNvPr>
          <p:cNvGrpSpPr/>
          <p:nvPr/>
        </p:nvGrpSpPr>
        <p:grpSpPr>
          <a:xfrm>
            <a:off x="92606" y="567851"/>
            <a:ext cx="12006788" cy="2340000"/>
            <a:chOff x="92606" y="3521100"/>
            <a:chExt cx="12006788" cy="2340000"/>
          </a:xfrm>
        </p:grpSpPr>
        <p:grpSp>
          <p:nvGrpSpPr>
            <p:cNvPr id="3" name="Groupe 42">
              <a:extLst>
                <a:ext uri="{FF2B5EF4-FFF2-40B4-BE49-F238E27FC236}">
                  <a16:creationId xmlns:a16="http://schemas.microsoft.com/office/drawing/2014/main" id="{D9AA3CF2-66FD-4953-56B3-6B03E9C222D6}"/>
                </a:ext>
              </a:extLst>
            </p:cNvPr>
            <p:cNvGrpSpPr/>
            <p:nvPr/>
          </p:nvGrpSpPr>
          <p:grpSpPr>
            <a:xfrm>
              <a:off x="92606" y="3521100"/>
              <a:ext cx="12006788" cy="2340000"/>
              <a:chOff x="185212" y="3635400"/>
              <a:chExt cx="12006788" cy="2340000"/>
            </a:xfrm>
          </p:grpSpPr>
          <p:pic>
            <p:nvPicPr>
              <p:cNvPr id="16" name="Graphique 35">
                <a:extLst>
                  <a:ext uri="{FF2B5EF4-FFF2-40B4-BE49-F238E27FC236}">
                    <a16:creationId xmlns:a16="http://schemas.microsoft.com/office/drawing/2014/main" id="{F94DDE06-50CC-2E02-3AF0-6FB45324D5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6188606" y="3635400"/>
                <a:ext cx="3001697" cy="2340000"/>
              </a:xfrm>
              <a:prstGeom prst="rect">
                <a:avLst/>
              </a:prstGeom>
            </p:spPr>
          </p:pic>
          <p:pic>
            <p:nvPicPr>
              <p:cNvPr id="17" name="Graphique 37">
                <a:extLst>
                  <a:ext uri="{FF2B5EF4-FFF2-40B4-BE49-F238E27FC236}">
                    <a16:creationId xmlns:a16="http://schemas.microsoft.com/office/drawing/2014/main" id="{CB4AF970-9F75-0983-D485-7E43D783D4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tretch>
                <a:fillRect/>
              </a:stretch>
            </p:blipFill>
            <p:spPr>
              <a:xfrm>
                <a:off x="3186909" y="3635400"/>
                <a:ext cx="3001697" cy="2340000"/>
              </a:xfrm>
              <a:prstGeom prst="rect">
                <a:avLst/>
              </a:prstGeom>
            </p:spPr>
          </p:pic>
          <p:pic>
            <p:nvPicPr>
              <p:cNvPr id="18" name="Graphique 39">
                <a:extLst>
                  <a:ext uri="{FF2B5EF4-FFF2-40B4-BE49-F238E27FC236}">
                    <a16:creationId xmlns:a16="http://schemas.microsoft.com/office/drawing/2014/main" id="{81FFC029-7425-EBDD-AE21-A920F356BA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185212" y="3635400"/>
                <a:ext cx="3001697" cy="2340000"/>
              </a:xfrm>
              <a:prstGeom prst="rect">
                <a:avLst/>
              </a:prstGeom>
            </p:spPr>
          </p:pic>
          <p:pic>
            <p:nvPicPr>
              <p:cNvPr id="19" name="Graphique 41">
                <a:extLst>
                  <a:ext uri="{FF2B5EF4-FFF2-40B4-BE49-F238E27FC236}">
                    <a16:creationId xmlns:a16="http://schemas.microsoft.com/office/drawing/2014/main" id="{65D2EA26-1CF4-FF48-CEDE-FC425DDD2E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9"/>
                  </a:ext>
                </a:extLst>
              </a:blip>
              <a:stretch>
                <a:fillRect/>
              </a:stretch>
            </p:blipFill>
            <p:spPr>
              <a:xfrm>
                <a:off x="9190303" y="3635400"/>
                <a:ext cx="3001697" cy="2340000"/>
              </a:xfrm>
              <a:prstGeom prst="rect">
                <a:avLst/>
              </a:prstGeom>
            </p:spPr>
          </p:pic>
        </p:grpSp>
        <p:grpSp>
          <p:nvGrpSpPr>
            <p:cNvPr id="4" name="Groupe 9">
              <a:extLst>
                <a:ext uri="{FF2B5EF4-FFF2-40B4-BE49-F238E27FC236}">
                  <a16:creationId xmlns:a16="http://schemas.microsoft.com/office/drawing/2014/main" id="{453CC4DE-D26F-5DC9-7EC7-74E062381774}"/>
                </a:ext>
              </a:extLst>
            </p:cNvPr>
            <p:cNvGrpSpPr/>
            <p:nvPr/>
          </p:nvGrpSpPr>
          <p:grpSpPr>
            <a:xfrm>
              <a:off x="610795" y="3745186"/>
              <a:ext cx="2257280" cy="307777"/>
              <a:chOff x="7187258" y="2050449"/>
              <a:chExt cx="2469662" cy="377003"/>
            </a:xfrm>
          </p:grpSpPr>
          <p:sp>
            <p:nvSpPr>
              <p:cNvPr id="14" name="ZoneTexte 10">
                <a:extLst>
                  <a:ext uri="{FF2B5EF4-FFF2-40B4-BE49-F238E27FC236}">
                    <a16:creationId xmlns:a16="http://schemas.microsoft.com/office/drawing/2014/main" id="{1CE0C9F6-1906-839B-5964-690C2D10F863}"/>
                  </a:ext>
                </a:extLst>
              </p:cNvPr>
              <p:cNvSpPr txBox="1"/>
              <p:nvPr/>
            </p:nvSpPr>
            <p:spPr>
              <a:xfrm>
                <a:off x="7187258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592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948 </a:t>
                </a:r>
                <a:endParaRPr lang="en-GB" sz="700" baseline="-25000" dirty="0"/>
              </a:p>
            </p:txBody>
          </p:sp>
          <p:sp>
            <p:nvSpPr>
              <p:cNvPr id="15" name="ZoneTexte 11">
                <a:extLst>
                  <a:ext uri="{FF2B5EF4-FFF2-40B4-BE49-F238E27FC236}">
                    <a16:creationId xmlns:a16="http://schemas.microsoft.com/office/drawing/2014/main" id="{D8BD9921-3051-8F53-12BF-A7F085BFE6BE}"/>
                  </a:ext>
                </a:extLst>
              </p:cNvPr>
              <p:cNvSpPr txBox="1"/>
              <p:nvPr/>
            </p:nvSpPr>
            <p:spPr>
              <a:xfrm>
                <a:off x="8666320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685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984 </a:t>
                </a:r>
                <a:endParaRPr lang="en-GB" sz="700" baseline="-25000" dirty="0"/>
              </a:p>
            </p:txBody>
          </p:sp>
        </p:grpSp>
        <p:grpSp>
          <p:nvGrpSpPr>
            <p:cNvPr id="5" name="Groupe 12">
              <a:extLst>
                <a:ext uri="{FF2B5EF4-FFF2-40B4-BE49-F238E27FC236}">
                  <a16:creationId xmlns:a16="http://schemas.microsoft.com/office/drawing/2014/main" id="{E7ECA1B3-4C11-DBC0-9ED4-BC9FE20DBFF6}"/>
                </a:ext>
              </a:extLst>
            </p:cNvPr>
            <p:cNvGrpSpPr/>
            <p:nvPr/>
          </p:nvGrpSpPr>
          <p:grpSpPr>
            <a:xfrm>
              <a:off x="3612492" y="3745185"/>
              <a:ext cx="2257280" cy="307777"/>
              <a:chOff x="7187258" y="2050449"/>
              <a:chExt cx="2469662" cy="377003"/>
            </a:xfrm>
          </p:grpSpPr>
          <p:sp>
            <p:nvSpPr>
              <p:cNvPr id="12" name="ZoneTexte 13">
                <a:extLst>
                  <a:ext uri="{FF2B5EF4-FFF2-40B4-BE49-F238E27FC236}">
                    <a16:creationId xmlns:a16="http://schemas.microsoft.com/office/drawing/2014/main" id="{AE1D6145-9520-DF6E-97B2-C16960C3B402}"/>
                  </a:ext>
                </a:extLst>
              </p:cNvPr>
              <p:cNvSpPr txBox="1"/>
              <p:nvPr/>
            </p:nvSpPr>
            <p:spPr>
              <a:xfrm>
                <a:off x="7187258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</a:t>
                </a:r>
                <a:r>
                  <a:rPr lang="en-GB" sz="700" b="1" dirty="0"/>
                  <a:t>0.047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</a:t>
                </a:r>
                <a:r>
                  <a:rPr lang="en-GB" sz="700" b="1" dirty="0"/>
                  <a:t>0.008</a:t>
                </a:r>
                <a:r>
                  <a:rPr lang="en-GB" sz="700" dirty="0"/>
                  <a:t> </a:t>
                </a:r>
                <a:endParaRPr lang="en-GB" sz="700" baseline="-25000" dirty="0"/>
              </a:p>
            </p:txBody>
          </p:sp>
          <p:sp>
            <p:nvSpPr>
              <p:cNvPr id="13" name="ZoneTexte 14">
                <a:extLst>
                  <a:ext uri="{FF2B5EF4-FFF2-40B4-BE49-F238E27FC236}">
                    <a16:creationId xmlns:a16="http://schemas.microsoft.com/office/drawing/2014/main" id="{DC6A18BD-D7CF-74CF-4C33-B5289CC45ABE}"/>
                  </a:ext>
                </a:extLst>
              </p:cNvPr>
              <p:cNvSpPr txBox="1"/>
              <p:nvPr/>
            </p:nvSpPr>
            <p:spPr>
              <a:xfrm>
                <a:off x="8666320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900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677 </a:t>
                </a:r>
                <a:endParaRPr lang="en-GB" sz="700" baseline="-25000" dirty="0"/>
              </a:p>
            </p:txBody>
          </p:sp>
        </p:grpSp>
        <p:grpSp>
          <p:nvGrpSpPr>
            <p:cNvPr id="6" name="Groupe 18">
              <a:extLst>
                <a:ext uri="{FF2B5EF4-FFF2-40B4-BE49-F238E27FC236}">
                  <a16:creationId xmlns:a16="http://schemas.microsoft.com/office/drawing/2014/main" id="{CAB8B66C-AF6B-1021-259C-EB25FE87167D}"/>
                </a:ext>
              </a:extLst>
            </p:cNvPr>
            <p:cNvGrpSpPr/>
            <p:nvPr/>
          </p:nvGrpSpPr>
          <p:grpSpPr>
            <a:xfrm>
              <a:off x="6614189" y="3745185"/>
              <a:ext cx="2257280" cy="307777"/>
              <a:chOff x="7187258" y="2050449"/>
              <a:chExt cx="2469662" cy="377003"/>
            </a:xfrm>
          </p:grpSpPr>
          <p:sp>
            <p:nvSpPr>
              <p:cNvPr id="10" name="ZoneTexte 19">
                <a:extLst>
                  <a:ext uri="{FF2B5EF4-FFF2-40B4-BE49-F238E27FC236}">
                    <a16:creationId xmlns:a16="http://schemas.microsoft.com/office/drawing/2014/main" id="{D5FFD409-8ECB-2FEE-11C0-13827A6DB565}"/>
                  </a:ext>
                </a:extLst>
              </p:cNvPr>
              <p:cNvSpPr txBox="1"/>
              <p:nvPr/>
            </p:nvSpPr>
            <p:spPr>
              <a:xfrm>
                <a:off x="7187258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278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283 </a:t>
                </a:r>
                <a:endParaRPr lang="en-GB" sz="700" baseline="-25000" dirty="0"/>
              </a:p>
            </p:txBody>
          </p:sp>
          <p:sp>
            <p:nvSpPr>
              <p:cNvPr id="11" name="ZoneTexte 20">
                <a:extLst>
                  <a:ext uri="{FF2B5EF4-FFF2-40B4-BE49-F238E27FC236}">
                    <a16:creationId xmlns:a16="http://schemas.microsoft.com/office/drawing/2014/main" id="{86850D65-A88B-8709-57CE-767BFCA0014D}"/>
                  </a:ext>
                </a:extLst>
              </p:cNvPr>
              <p:cNvSpPr txBox="1"/>
              <p:nvPr/>
            </p:nvSpPr>
            <p:spPr>
              <a:xfrm>
                <a:off x="8666320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437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770 </a:t>
                </a:r>
                <a:endParaRPr lang="en-GB" sz="700" baseline="-25000" dirty="0"/>
              </a:p>
            </p:txBody>
          </p:sp>
        </p:grpSp>
        <p:grpSp>
          <p:nvGrpSpPr>
            <p:cNvPr id="7" name="Groupe 27">
              <a:extLst>
                <a:ext uri="{FF2B5EF4-FFF2-40B4-BE49-F238E27FC236}">
                  <a16:creationId xmlns:a16="http://schemas.microsoft.com/office/drawing/2014/main" id="{A7A290E9-DED9-6D2B-A5C4-30AE9112F419}"/>
                </a:ext>
              </a:extLst>
            </p:cNvPr>
            <p:cNvGrpSpPr/>
            <p:nvPr/>
          </p:nvGrpSpPr>
          <p:grpSpPr>
            <a:xfrm>
              <a:off x="9615886" y="3745185"/>
              <a:ext cx="2257280" cy="307777"/>
              <a:chOff x="7187258" y="2050449"/>
              <a:chExt cx="2469662" cy="377003"/>
            </a:xfrm>
          </p:grpSpPr>
          <p:sp>
            <p:nvSpPr>
              <p:cNvPr id="8" name="ZoneTexte 28">
                <a:extLst>
                  <a:ext uri="{FF2B5EF4-FFF2-40B4-BE49-F238E27FC236}">
                    <a16:creationId xmlns:a16="http://schemas.microsoft.com/office/drawing/2014/main" id="{B738FB13-630D-119D-8EB2-90F6F3226A4F}"/>
                  </a:ext>
                </a:extLst>
              </p:cNvPr>
              <p:cNvSpPr txBox="1"/>
              <p:nvPr/>
            </p:nvSpPr>
            <p:spPr>
              <a:xfrm>
                <a:off x="7187258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578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360</a:t>
                </a:r>
                <a:endParaRPr lang="en-GB" sz="700" baseline="-25000" dirty="0"/>
              </a:p>
            </p:txBody>
          </p:sp>
          <p:sp>
            <p:nvSpPr>
              <p:cNvPr id="9" name="ZoneTexte 29">
                <a:extLst>
                  <a:ext uri="{FF2B5EF4-FFF2-40B4-BE49-F238E27FC236}">
                    <a16:creationId xmlns:a16="http://schemas.microsoft.com/office/drawing/2014/main" id="{4839E198-932F-4639-B480-7A8D8F75D54B}"/>
                  </a:ext>
                </a:extLst>
              </p:cNvPr>
              <p:cNvSpPr txBox="1"/>
              <p:nvPr/>
            </p:nvSpPr>
            <p:spPr>
              <a:xfrm>
                <a:off x="8666320" y="2050449"/>
                <a:ext cx="990600" cy="3770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fr-FR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GB" sz="700" dirty="0"/>
                  <a:t>p    = 0.627</a:t>
                </a:r>
              </a:p>
              <a:p>
                <a:pPr algn="ctr"/>
                <a:r>
                  <a:rPr lang="en-GB" sz="700" dirty="0" err="1"/>
                  <a:t>p</a:t>
                </a:r>
                <a:r>
                  <a:rPr lang="en-GB" sz="700" baseline="-25000" dirty="0" err="1"/>
                  <a:t>adj</a:t>
                </a:r>
                <a:r>
                  <a:rPr lang="en-GB" sz="700" dirty="0"/>
                  <a:t>= 0.839 </a:t>
                </a:r>
                <a:endParaRPr lang="en-GB" sz="700" baseline="-25000" dirty="0"/>
              </a:p>
            </p:txBody>
          </p:sp>
        </p:grp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4EAD6D49-EA28-9FC6-E53C-99549A88D9D0}"/>
              </a:ext>
            </a:extLst>
          </p:cNvPr>
          <p:cNvSpPr txBox="1"/>
          <p:nvPr/>
        </p:nvSpPr>
        <p:spPr>
          <a:xfrm>
            <a:off x="2635045" y="3903406"/>
            <a:ext cx="747251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2. Comparison of </a:t>
            </a:r>
            <a:r>
              <a:rPr lang="en-GB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200" b="1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med</a:t>
            </a: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etween CKD patients and controls in the high- and low-fatigue groups within different time periods.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GB" sz="1200" b="1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2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med</a:t>
            </a: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Instantaneous median frequency; FACIT-F: Functional assessment in chronic illness therapy fatigue scale; CKD: chronic kidney disease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46411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28">
            <a:extLst>
              <a:ext uri="{FF2B5EF4-FFF2-40B4-BE49-F238E27FC236}">
                <a16:creationId xmlns:a16="http://schemas.microsoft.com/office/drawing/2014/main" id="{201AC359-3BD0-6B9B-3FDC-088270706A1F}"/>
              </a:ext>
            </a:extLst>
          </p:cNvPr>
          <p:cNvGrpSpPr/>
          <p:nvPr/>
        </p:nvGrpSpPr>
        <p:grpSpPr>
          <a:xfrm>
            <a:off x="2756104" y="297426"/>
            <a:ext cx="9210825" cy="6400800"/>
            <a:chOff x="1733550" y="228600"/>
            <a:chExt cx="9210825" cy="6400800"/>
          </a:xfrm>
        </p:grpSpPr>
        <p:pic>
          <p:nvPicPr>
            <p:cNvPr id="3" name="Graphique 2">
              <a:extLst>
                <a:ext uri="{FF2B5EF4-FFF2-40B4-BE49-F238E27FC236}">
                  <a16:creationId xmlns:a16="http://schemas.microsoft.com/office/drawing/2014/main" id="{D6116F69-CB6E-8B65-E12A-2B1F8F24EE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733550" y="228600"/>
              <a:ext cx="8724900" cy="6400800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5836B0DB-8401-2395-5EFA-7171722A3C91}"/>
                </a:ext>
              </a:extLst>
            </p:cNvPr>
            <p:cNvSpPr/>
            <p:nvPr/>
          </p:nvSpPr>
          <p:spPr>
            <a:xfrm>
              <a:off x="2276454" y="52640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5" name="Groupe 7">
              <a:extLst>
                <a:ext uri="{FF2B5EF4-FFF2-40B4-BE49-F238E27FC236}">
                  <a16:creationId xmlns:a16="http://schemas.microsoft.com/office/drawing/2014/main" id="{A867A70D-987C-0AAA-B633-2D9D6D1E5555}"/>
                </a:ext>
              </a:extLst>
            </p:cNvPr>
            <p:cNvGrpSpPr/>
            <p:nvPr/>
          </p:nvGrpSpPr>
          <p:grpSpPr>
            <a:xfrm>
              <a:off x="9594375" y="4437636"/>
              <a:ext cx="1350000" cy="1617222"/>
              <a:chOff x="9613425" y="4170936"/>
              <a:chExt cx="1350000" cy="1617222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D9A9E536-1740-2BEE-1A61-3557650C63BC}"/>
                  </a:ext>
                </a:extLst>
              </p:cNvPr>
              <p:cNvSpPr/>
              <p:nvPr/>
            </p:nvSpPr>
            <p:spPr>
              <a:xfrm>
                <a:off x="9613425" y="4170936"/>
                <a:ext cx="1350000" cy="324000"/>
              </a:xfrm>
              <a:prstGeom prst="rect">
                <a:avLst/>
              </a:prstGeom>
              <a:noFill/>
              <a:ln w="38100" cap="sq">
                <a:solidFill>
                  <a:schemeClr val="tx1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dirty="0">
                    <a:solidFill>
                      <a:schemeClr val="tx1"/>
                    </a:solidFill>
                  </a:rPr>
                  <a:t>General fatigue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89E7A2BE-C0F9-F02F-F0E2-51B57C709924}"/>
                  </a:ext>
                </a:extLst>
              </p:cNvPr>
              <p:cNvSpPr/>
              <p:nvPr/>
            </p:nvSpPr>
            <p:spPr>
              <a:xfrm>
                <a:off x="9613425" y="4602010"/>
                <a:ext cx="1350000" cy="324000"/>
              </a:xfrm>
              <a:prstGeom prst="rect">
                <a:avLst/>
              </a:prstGeom>
              <a:noFill/>
              <a:ln w="38100" cap="sq">
                <a:solidFill>
                  <a:srgbClr val="FF66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dirty="0">
                    <a:solidFill>
                      <a:schemeClr val="tx1"/>
                    </a:solidFill>
                  </a:rPr>
                  <a:t>Mental fatigue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9D171CB1-EF12-C7AB-7E38-257A46951C08}"/>
                  </a:ext>
                </a:extLst>
              </p:cNvPr>
              <p:cNvSpPr/>
              <p:nvPr/>
            </p:nvSpPr>
            <p:spPr>
              <a:xfrm>
                <a:off x="9613425" y="5033084"/>
                <a:ext cx="1350000" cy="324000"/>
              </a:xfrm>
              <a:prstGeom prst="rect">
                <a:avLst/>
              </a:prstGeom>
              <a:noFill/>
              <a:ln w="38100" cap="sq">
                <a:solidFill>
                  <a:srgbClr val="0000FF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dirty="0">
                    <a:solidFill>
                      <a:schemeClr val="tx1"/>
                    </a:solidFill>
                  </a:rPr>
                  <a:t>Reduced Activities </a:t>
                </a: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DE124016-FD60-A418-0C37-14E938B66B94}"/>
                  </a:ext>
                </a:extLst>
              </p:cNvPr>
              <p:cNvSpPr/>
              <p:nvPr/>
            </p:nvSpPr>
            <p:spPr>
              <a:xfrm>
                <a:off x="9613425" y="5464158"/>
                <a:ext cx="1350000" cy="324000"/>
              </a:xfrm>
              <a:prstGeom prst="rect">
                <a:avLst/>
              </a:prstGeom>
              <a:noFill/>
              <a:ln w="38100" cap="sq">
                <a:solidFill>
                  <a:srgbClr val="FF006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000" dirty="0">
                    <a:solidFill>
                      <a:schemeClr val="tx1"/>
                    </a:solidFill>
                  </a:rPr>
                  <a:t>Reduced Motivation </a:t>
                </a:r>
              </a:p>
            </p:txBody>
          </p:sp>
        </p:grpSp>
        <p:sp>
          <p:nvSpPr>
            <p:cNvPr id="6" name="ZoneTexte 8">
              <a:extLst>
                <a:ext uri="{FF2B5EF4-FFF2-40B4-BE49-F238E27FC236}">
                  <a16:creationId xmlns:a16="http://schemas.microsoft.com/office/drawing/2014/main" id="{3D8CA512-106A-074D-EBD8-5CC7A0462F61}"/>
                </a:ext>
              </a:extLst>
            </p:cNvPr>
            <p:cNvSpPr txBox="1"/>
            <p:nvPr/>
          </p:nvSpPr>
          <p:spPr>
            <a:xfrm>
              <a:off x="9482002" y="4170805"/>
              <a:ext cx="13491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MFI-20 subscales :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025A9DE1-CDBE-28AD-75B3-B879E28AE886}"/>
                </a:ext>
              </a:extLst>
            </p:cNvPr>
            <p:cNvSpPr/>
            <p:nvPr/>
          </p:nvSpPr>
          <p:spPr>
            <a:xfrm>
              <a:off x="8019757" y="52640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85C1DF1-0330-7F85-BBBD-8DD0BBFEA52B}"/>
                </a:ext>
              </a:extLst>
            </p:cNvPr>
            <p:cNvSpPr/>
            <p:nvPr/>
          </p:nvSpPr>
          <p:spPr>
            <a:xfrm>
              <a:off x="3710647" y="333558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3ED28A78-115D-4500-7E93-FF259EE25ED9}"/>
                </a:ext>
              </a:extLst>
            </p:cNvPr>
            <p:cNvSpPr/>
            <p:nvPr/>
          </p:nvSpPr>
          <p:spPr>
            <a:xfrm>
              <a:off x="2276454" y="4742579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B1C37213-6894-923B-B95F-1F3675ADB50A}"/>
                </a:ext>
              </a:extLst>
            </p:cNvPr>
            <p:cNvSpPr/>
            <p:nvPr/>
          </p:nvSpPr>
          <p:spPr>
            <a:xfrm>
              <a:off x="3710647" y="52640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9283C72-E69C-45A1-FB0A-9655EFA934F8}"/>
                </a:ext>
              </a:extLst>
            </p:cNvPr>
            <p:cNvSpPr/>
            <p:nvPr/>
          </p:nvSpPr>
          <p:spPr>
            <a:xfrm>
              <a:off x="5143250" y="1933127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1917856-98CE-13F3-9825-E633CBCB58D8}"/>
                </a:ext>
              </a:extLst>
            </p:cNvPr>
            <p:cNvSpPr/>
            <p:nvPr/>
          </p:nvSpPr>
          <p:spPr>
            <a:xfrm>
              <a:off x="6582127" y="333177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E45A8C5A-C47E-FCF9-1A9B-B42D713C0CF6}"/>
                </a:ext>
              </a:extLst>
            </p:cNvPr>
            <p:cNvSpPr/>
            <p:nvPr/>
          </p:nvSpPr>
          <p:spPr>
            <a:xfrm>
              <a:off x="8019757" y="4737898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C4D6EDB-1812-01EC-3512-F62BBA16A930}"/>
                </a:ext>
              </a:extLst>
            </p:cNvPr>
            <p:cNvSpPr/>
            <p:nvPr/>
          </p:nvSpPr>
          <p:spPr>
            <a:xfrm>
              <a:off x="5140108" y="526400"/>
              <a:ext cx="1350000" cy="324000"/>
            </a:xfrm>
            <a:prstGeom prst="rect">
              <a:avLst/>
            </a:prstGeom>
            <a:noFill/>
            <a:ln w="38100" cap="sq"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3A2F2D0-3FA2-48DB-7071-0C7C1801680D}"/>
                </a:ext>
              </a:extLst>
            </p:cNvPr>
            <p:cNvSpPr/>
            <p:nvPr/>
          </p:nvSpPr>
          <p:spPr>
            <a:xfrm>
              <a:off x="3710647" y="1930990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7B8FEE6-340F-F3FB-73AE-4478E8F6243C}"/>
                </a:ext>
              </a:extLst>
            </p:cNvPr>
            <p:cNvSpPr/>
            <p:nvPr/>
          </p:nvSpPr>
          <p:spPr>
            <a:xfrm>
              <a:off x="2274907" y="3331770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2A3DFF4-77BD-5096-AB08-09905ED38D90}"/>
                </a:ext>
              </a:extLst>
            </p:cNvPr>
            <p:cNvSpPr/>
            <p:nvPr/>
          </p:nvSpPr>
          <p:spPr>
            <a:xfrm>
              <a:off x="5140108" y="3341124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B453E4C-6577-4CDC-F862-9F35F81FD935}"/>
                </a:ext>
              </a:extLst>
            </p:cNvPr>
            <p:cNvSpPr/>
            <p:nvPr/>
          </p:nvSpPr>
          <p:spPr>
            <a:xfrm>
              <a:off x="6582127" y="4737898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6A2C6033-D2C9-6495-FBE1-D5F6E57DF584}"/>
                </a:ext>
              </a:extLst>
            </p:cNvPr>
            <p:cNvSpPr/>
            <p:nvPr/>
          </p:nvSpPr>
          <p:spPr>
            <a:xfrm>
              <a:off x="6582127" y="1925642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2A1905DE-5841-D173-3608-269C8075B52F}"/>
                </a:ext>
              </a:extLst>
            </p:cNvPr>
            <p:cNvSpPr/>
            <p:nvPr/>
          </p:nvSpPr>
          <p:spPr>
            <a:xfrm>
              <a:off x="5140108" y="4737898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66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B6416489-84D6-5294-B479-AE5C9E2FB3C6}"/>
                </a:ext>
              </a:extLst>
            </p:cNvPr>
            <p:cNvSpPr/>
            <p:nvPr/>
          </p:nvSpPr>
          <p:spPr>
            <a:xfrm>
              <a:off x="2276454" y="1920961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0000FF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F693A950-A5F5-7194-290E-D0C21380AF42}"/>
                </a:ext>
              </a:extLst>
            </p:cNvPr>
            <p:cNvSpPr/>
            <p:nvPr/>
          </p:nvSpPr>
          <p:spPr>
            <a:xfrm>
              <a:off x="8011588" y="1920961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0000FF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B532A17-FA9C-6C52-9371-5088F6AD84E4}"/>
                </a:ext>
              </a:extLst>
            </p:cNvPr>
            <p:cNvSpPr/>
            <p:nvPr/>
          </p:nvSpPr>
          <p:spPr>
            <a:xfrm>
              <a:off x="3712782" y="4746399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0000FF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F9FBF6CF-480B-5B3A-169B-FBEDAE958ADC}"/>
                </a:ext>
              </a:extLst>
            </p:cNvPr>
            <p:cNvSpPr/>
            <p:nvPr/>
          </p:nvSpPr>
          <p:spPr>
            <a:xfrm>
              <a:off x="6590296" y="526400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006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2B5DF995-7AC4-CF04-924D-352E17179F92}"/>
                </a:ext>
              </a:extLst>
            </p:cNvPr>
            <p:cNvSpPr/>
            <p:nvPr/>
          </p:nvSpPr>
          <p:spPr>
            <a:xfrm>
              <a:off x="8017867" y="3331770"/>
              <a:ext cx="1350000" cy="324000"/>
            </a:xfrm>
            <a:prstGeom prst="rect">
              <a:avLst/>
            </a:prstGeom>
            <a:noFill/>
            <a:ln w="38100" cap="sq">
              <a:solidFill>
                <a:srgbClr val="FF006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 dirty="0">
                <a:solidFill>
                  <a:schemeClr val="tx1"/>
                </a:solidFill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C7EF0FDC-23C5-F93C-88BB-61335193E467}"/>
              </a:ext>
            </a:extLst>
          </p:cNvPr>
          <p:cNvSpPr txBox="1"/>
          <p:nvPr/>
        </p:nvSpPr>
        <p:spPr>
          <a:xfrm>
            <a:off x="294968" y="914400"/>
            <a:ext cx="2182761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3. Comparison of the MFI-20 items between CKD patients and controls.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FI-20: Multidimensional fatigue inventory; CKD: chronic kidney disease.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5901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que 2">
            <a:extLst>
              <a:ext uri="{FF2B5EF4-FFF2-40B4-BE49-F238E27FC236}">
                <a16:creationId xmlns:a16="http://schemas.microsoft.com/office/drawing/2014/main" id="{70101374-AB46-6C3F-6018-1FB15D5264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910627" y="280987"/>
            <a:ext cx="8067675" cy="62960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929DD33-F96C-745C-5A3C-1D1033014C25}"/>
              </a:ext>
            </a:extLst>
          </p:cNvPr>
          <p:cNvSpPr txBox="1"/>
          <p:nvPr/>
        </p:nvSpPr>
        <p:spPr>
          <a:xfrm>
            <a:off x="245806" y="855406"/>
            <a:ext cx="3362633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4. Comparison of the FACIT-F items between CKD patients and controls. </a:t>
            </a: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200" b="1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CIT-F: Functional assessment in chronic illness therapy fatigue scale; CKD: chronic kidney disease.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31694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6</TotalTime>
  <Words>285</Words>
  <Application>Microsoft Office PowerPoint</Application>
  <PresentationFormat>Widescreen</PresentationFormat>
  <Paragraphs>3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toine</dc:creator>
  <cp:lastModifiedBy>Bryan Nyary</cp:lastModifiedBy>
  <cp:revision>19</cp:revision>
  <dcterms:created xsi:type="dcterms:W3CDTF">2022-06-02T08:32:54Z</dcterms:created>
  <dcterms:modified xsi:type="dcterms:W3CDTF">2022-11-16T19:10:31Z</dcterms:modified>
</cp:coreProperties>
</file>